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 varScale="1">
        <p:scale>
          <a:sx n="97" d="100"/>
          <a:sy n="97" d="100"/>
        </p:scale>
        <p:origin x="89" y="7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626E3-AD3C-45A2-A055-A3F6C1BCBC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C00573-D522-4887-8C3B-A2CC47E4CB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CFD8D2-3365-41BD-AC26-42C74E1E9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C51D20-3DBD-47FA-95B8-E4465328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FAD23-848A-44DC-ABA7-A9C8FA604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5973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BA4E6C-BA21-409C-91B7-0409072CB1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1F735D-BDCC-4726-9368-3FE13784AA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1955D2-8DAD-4BBB-82BF-5421BF4DC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E1F16-6839-4A44-88B9-32AABF83B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6C1B7-D257-413F-B8D1-A7F8444E2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3575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8BF0F5-E9B9-4D42-BC71-27DEB2E33C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FF10AD-3850-4BB9-BF1B-901C000EEB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76353C-780C-417E-8741-C2F8D9F32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3FD5F0-FC77-4289-987F-701DDC83E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E7E31-91DB-4DAD-8EF6-BCE99990D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094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521B6-22A0-4824-9E2D-68CB6AF0B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6029AF-A557-43DD-ACCA-94B20CEDC0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F96729-1544-4509-8961-4077D2B3E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E985A-F066-47A9-B88B-220999495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596695-39F2-4189-AEDA-F1E180CEA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2320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76A83-84CB-4E6C-B3F9-F4A9659CE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B95BA4-2E01-4C61-A35F-1DA6DF956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F934F4-B783-450E-AD76-2D3A3DAF4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BF29BF-B36F-4CC5-AE06-9A3AAC0AE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452D4A-D7D0-4480-AA81-C0EA577B5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327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77BBB-E43B-4045-8653-5C2A957CCB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51555-A809-4B5E-B920-67A14F4D83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88A56C-23E7-40EB-A376-E6CEE8B912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E747DB-D84B-4203-91E2-5A385E7C3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CCF76A-E271-429A-8213-7BDDED14B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D20C69-7DAF-4C0F-AB56-CFD04BA36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2735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885C9-764E-4C18-B8A8-EAAB011E13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07497E-00BC-4DDD-8F3B-D1A3E57151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7BBE18-9D97-4EBF-9C5C-66DD95BE61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D9B3EC-7D79-47BA-B24A-F81857A008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48E3FD-4FFE-4765-A7D5-0122DA4243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1A23A1-1E6C-42E2-BB1B-8E9EB8D77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BF5739-9DEE-4831-A2FB-EB1F15B6C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9BE7C4-82C9-49C0-9EBC-B445B3D10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90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19EC3-D1AB-40AC-AC59-1FA21F8ED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A8A4DC-55A0-4933-9EA7-1DD177178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C1CCEB-3A23-4B2D-84E0-948140C48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78648B-A4D3-49D3-8DC0-736D1B378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9705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EBAAE1-477B-4BE1-95F1-71BDFBD19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EC82BD-40D8-4ECA-9CE4-4843A5D3F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0BCC12-28EB-4643-8949-805B95ABA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30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30F96-95FF-4609-A59D-8735F27E0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4DE3FD-00B9-41D0-9178-AA916809CF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35D4E8-D7A8-4C47-A82A-76D20CCF56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87551A-598D-402A-80B6-55C5282FA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33F25B-58B9-4E6A-9C5E-A565A261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04F05E-E56D-4733-8033-ED4743550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535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19F11-BD85-4BE9-A64A-9E562CF9A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06D76C-8249-4A7B-9AEA-1E3B73630E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660390-664A-4ABF-BC37-40AA8535E5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5D6C5F-9CE0-487A-9CEA-80E2C942C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DBDC1E-4332-46BC-AE4F-659BCF514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57AE67-2FAB-4FFF-A995-78AFF408B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4691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AB890A-36F4-4CB4-9919-8C1CF1C09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5B1D2F-64A2-4B07-854E-5FE0D4A2A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BAACEC-3469-448F-B861-8CF351FCF8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55AA4D-5E07-4752-814D-9299A913B8AA}" type="datetimeFigureOut">
              <a:rPr lang="fr-FR" smtClean="0"/>
              <a:t>05/04/2020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ED378B-82D6-4C10-AB26-7F1EAF7C5B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679CFE-6714-412D-889B-511FD1FF87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9F202-B27D-4540-A207-A1FB871246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1388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CE99B8D-E101-405C-BA81-85D09A7C7B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3062" y="1931624"/>
            <a:ext cx="1308450" cy="13102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5BFD3CC-62C5-440E-A7B0-756BE81CAE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6736" y="1931624"/>
            <a:ext cx="1308450" cy="13102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673B17F-EF98-4DD7-BB3F-B91B4C6140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79388" y="1931624"/>
            <a:ext cx="1308450" cy="131028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83FB8F4-5DCB-4200-92DC-2EF27D6B0F1B}"/>
              </a:ext>
            </a:extLst>
          </p:cNvPr>
          <p:cNvSpPr txBox="1"/>
          <p:nvPr/>
        </p:nvSpPr>
        <p:spPr>
          <a:xfrm>
            <a:off x="8335841" y="2264328"/>
            <a:ext cx="21563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CD34+CD38-CD123+ </a:t>
            </a:r>
          </a:p>
          <a:p>
            <a:pPr algn="ctr"/>
            <a:r>
              <a:rPr lang="fr-FR" dirty="0"/>
              <a:t>0.2%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A943C20-9D67-45B9-A3F0-ACA72AB5B6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73062" y="3257076"/>
            <a:ext cx="1308450" cy="13102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5A4D774-5AF7-40E1-BB1F-0D97AFA8A9A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66736" y="3257076"/>
            <a:ext cx="1308450" cy="13102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BC57A5E-6F4B-4F0A-B2EB-2B4053B344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79388" y="3257076"/>
            <a:ext cx="1308450" cy="131028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1E780E7-E023-40FA-82E8-0711E3D9EA84}"/>
              </a:ext>
            </a:extLst>
          </p:cNvPr>
          <p:cNvSpPr txBox="1"/>
          <p:nvPr/>
        </p:nvSpPr>
        <p:spPr>
          <a:xfrm>
            <a:off x="8275186" y="3727550"/>
            <a:ext cx="21563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CD34+CD38-CD123+ </a:t>
            </a:r>
          </a:p>
          <a:p>
            <a:pPr algn="ctr"/>
            <a:r>
              <a:rPr lang="fr-FR" dirty="0"/>
              <a:t>6.3%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D57AEA7C-7C9E-4851-8713-A541753FEA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07019" y="4573832"/>
            <a:ext cx="1308450" cy="13102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F680021-C29C-4469-8575-60C588D20B5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73062" y="4573832"/>
            <a:ext cx="1308450" cy="131028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797BC544-F698-450A-BB07-35B9AD072E98}"/>
              </a:ext>
            </a:extLst>
          </p:cNvPr>
          <p:cNvSpPr txBox="1"/>
          <p:nvPr/>
        </p:nvSpPr>
        <p:spPr>
          <a:xfrm>
            <a:off x="8335841" y="4950379"/>
            <a:ext cx="21563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CD34+CD38-CD123+ </a:t>
            </a:r>
          </a:p>
          <a:p>
            <a:pPr algn="ctr"/>
            <a:r>
              <a:rPr lang="fr-FR" dirty="0"/>
              <a:t>55.4%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7A87D275-2527-48E8-BB08-94C73D48DB4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66736" y="4573832"/>
            <a:ext cx="1308450" cy="131028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943CA81-BA0D-4B1E-A461-28FA5CE31BD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79388" y="4573832"/>
            <a:ext cx="1308450" cy="1310280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E4693973-F4D5-4F55-99CD-31D27B2B5A87}"/>
              </a:ext>
            </a:extLst>
          </p:cNvPr>
          <p:cNvGrpSpPr/>
          <p:nvPr/>
        </p:nvGrpSpPr>
        <p:grpSpPr>
          <a:xfrm>
            <a:off x="1345075" y="5472230"/>
            <a:ext cx="892706" cy="888502"/>
            <a:chOff x="759149" y="4410715"/>
            <a:chExt cx="892706" cy="888502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642529CF-648E-4AB3-B6A1-2684B32D121A}"/>
                </a:ext>
              </a:extLst>
            </p:cNvPr>
            <p:cNvGrpSpPr/>
            <p:nvPr/>
          </p:nvGrpSpPr>
          <p:grpSpPr>
            <a:xfrm>
              <a:off x="1074197" y="4410715"/>
              <a:ext cx="541538" cy="540000"/>
              <a:chOff x="1074197" y="5280730"/>
              <a:chExt cx="541538" cy="540000"/>
            </a:xfrm>
          </p:grpSpPr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8611BB5A-A0DA-47BF-93FA-2F3FE4F084B0}"/>
                  </a:ext>
                </a:extLst>
              </p:cNvPr>
              <p:cNvCxnSpPr/>
              <p:nvPr/>
            </p:nvCxnSpPr>
            <p:spPr>
              <a:xfrm>
                <a:off x="1074197" y="5820730"/>
                <a:ext cx="54153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A74E5BB8-B1DD-41C8-8338-F50EAFA384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74197" y="5280730"/>
                <a:ext cx="0" cy="540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F863C07-B33E-430E-9D6C-5BE22055B7BE}"/>
                </a:ext>
              </a:extLst>
            </p:cNvPr>
            <p:cNvSpPr txBox="1"/>
            <p:nvPr/>
          </p:nvSpPr>
          <p:spPr>
            <a:xfrm rot="16200000">
              <a:off x="683968" y="4535057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SS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93255CE-FF46-4F20-AC4C-63F8AA605807}"/>
                </a:ext>
              </a:extLst>
            </p:cNvPr>
            <p:cNvSpPr txBox="1"/>
            <p:nvPr/>
          </p:nvSpPr>
          <p:spPr>
            <a:xfrm>
              <a:off x="967052" y="4929885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D45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4BA11BB8-B879-45D3-99A4-67A5C6ED1917}"/>
              </a:ext>
            </a:extLst>
          </p:cNvPr>
          <p:cNvSpPr txBox="1"/>
          <p:nvPr/>
        </p:nvSpPr>
        <p:spPr>
          <a:xfrm>
            <a:off x="1757895" y="1583123"/>
            <a:ext cx="1406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LEUKOCYTES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1B14E0AC-E083-43DB-972E-C6E27E2232E1}"/>
              </a:ext>
            </a:extLst>
          </p:cNvPr>
          <p:cNvGrpSpPr/>
          <p:nvPr/>
        </p:nvGrpSpPr>
        <p:grpSpPr>
          <a:xfrm>
            <a:off x="3479117" y="5438836"/>
            <a:ext cx="974213" cy="921896"/>
            <a:chOff x="2893191" y="4356491"/>
            <a:chExt cx="974213" cy="921896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26992D45-CD56-4F67-9DDE-2BA8120D9961}"/>
                </a:ext>
              </a:extLst>
            </p:cNvPr>
            <p:cNvGrpSpPr/>
            <p:nvPr/>
          </p:nvGrpSpPr>
          <p:grpSpPr>
            <a:xfrm>
              <a:off x="3208238" y="4389885"/>
              <a:ext cx="541538" cy="540000"/>
              <a:chOff x="1074197" y="5280730"/>
              <a:chExt cx="541538" cy="540000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037F9364-75F4-44F3-8D0D-C79E11D51110}"/>
                  </a:ext>
                </a:extLst>
              </p:cNvPr>
              <p:cNvCxnSpPr/>
              <p:nvPr/>
            </p:nvCxnSpPr>
            <p:spPr>
              <a:xfrm>
                <a:off x="1074197" y="5820730"/>
                <a:ext cx="54153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CB16F185-B8B5-41BA-8703-06762F3CE5F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74197" y="5280730"/>
                <a:ext cx="0" cy="540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677942B-ED33-4C16-AFC7-4B98268632B6}"/>
                </a:ext>
              </a:extLst>
            </p:cNvPr>
            <p:cNvSpPr txBox="1"/>
            <p:nvPr/>
          </p:nvSpPr>
          <p:spPr>
            <a:xfrm rot="16200000">
              <a:off x="2735455" y="4514227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D34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4B34B08-00F9-42AD-AB63-9A221BA4AA1F}"/>
                </a:ext>
              </a:extLst>
            </p:cNvPr>
            <p:cNvSpPr txBox="1"/>
            <p:nvPr/>
          </p:nvSpPr>
          <p:spPr>
            <a:xfrm>
              <a:off x="3065581" y="4909055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D117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1195CF1E-2006-4423-AC59-634A91F4ED87}"/>
              </a:ext>
            </a:extLst>
          </p:cNvPr>
          <p:cNvGrpSpPr/>
          <p:nvPr/>
        </p:nvGrpSpPr>
        <p:grpSpPr>
          <a:xfrm>
            <a:off x="5262174" y="5991400"/>
            <a:ext cx="684803" cy="369332"/>
            <a:chOff x="3065581" y="4909055"/>
            <a:chExt cx="684803" cy="369332"/>
          </a:xfrm>
        </p:grpSpPr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B9A7984B-2E59-41D0-821E-F675E85F3C4A}"/>
                </a:ext>
              </a:extLst>
            </p:cNvPr>
            <p:cNvCxnSpPr/>
            <p:nvPr/>
          </p:nvCxnSpPr>
          <p:spPr>
            <a:xfrm>
              <a:off x="3208238" y="4929885"/>
              <a:ext cx="54153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FD68CC4-19B5-4C9F-AFB8-CFA38C43927E}"/>
                </a:ext>
              </a:extLst>
            </p:cNvPr>
            <p:cNvSpPr txBox="1"/>
            <p:nvPr/>
          </p:nvSpPr>
          <p:spPr>
            <a:xfrm>
              <a:off x="3065581" y="4909055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D38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A2BA9AF2-40D5-46D1-B285-C2DAE6C95C99}"/>
              </a:ext>
            </a:extLst>
          </p:cNvPr>
          <p:cNvGrpSpPr/>
          <p:nvPr/>
        </p:nvGrpSpPr>
        <p:grpSpPr>
          <a:xfrm>
            <a:off x="6781512" y="5991400"/>
            <a:ext cx="801823" cy="369332"/>
            <a:chOff x="3065581" y="4909055"/>
            <a:chExt cx="801823" cy="369332"/>
          </a:xfrm>
        </p:grpSpPr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B15C6393-2E83-4245-ADD1-8FA7D973FE2D}"/>
                </a:ext>
              </a:extLst>
            </p:cNvPr>
            <p:cNvCxnSpPr/>
            <p:nvPr/>
          </p:nvCxnSpPr>
          <p:spPr>
            <a:xfrm>
              <a:off x="3208238" y="4929885"/>
              <a:ext cx="54153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F828534-02EF-47AF-8698-A92490A729AA}"/>
                </a:ext>
              </a:extLst>
            </p:cNvPr>
            <p:cNvSpPr txBox="1"/>
            <p:nvPr/>
          </p:nvSpPr>
          <p:spPr>
            <a:xfrm>
              <a:off x="3065581" y="4909055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D123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74FBB413-E598-44B9-8DB4-4777EB48DF8C}"/>
              </a:ext>
            </a:extLst>
          </p:cNvPr>
          <p:cNvSpPr txBox="1"/>
          <p:nvPr/>
        </p:nvSpPr>
        <p:spPr>
          <a:xfrm>
            <a:off x="5611783" y="1562292"/>
            <a:ext cx="1406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LASTS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9533EE73-0A60-4B89-95ED-53F33F44573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07018" y="1931624"/>
            <a:ext cx="1308450" cy="131028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6DA3F67-D80A-4D80-B215-ADEB92EEFA7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807018" y="3257076"/>
            <a:ext cx="1308450" cy="1310280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6C07EC2F-44B6-4A7D-AF96-B5882B4C631E}"/>
              </a:ext>
            </a:extLst>
          </p:cNvPr>
          <p:cNvSpPr txBox="1"/>
          <p:nvPr/>
        </p:nvSpPr>
        <p:spPr>
          <a:xfrm>
            <a:off x="1757894" y="1875077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#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D5F338C-3C87-4166-A64F-526548FA5292}"/>
              </a:ext>
            </a:extLst>
          </p:cNvPr>
          <p:cNvSpPr txBox="1"/>
          <p:nvPr/>
        </p:nvSpPr>
        <p:spPr>
          <a:xfrm>
            <a:off x="1757894" y="3209099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#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98DE20A-C7C6-4ABB-BE66-C7581641DACB}"/>
              </a:ext>
            </a:extLst>
          </p:cNvPr>
          <p:cNvSpPr txBox="1"/>
          <p:nvPr/>
        </p:nvSpPr>
        <p:spPr>
          <a:xfrm>
            <a:off x="1757894" y="4543121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#3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17A4B5A7-C3FD-43D4-AA9E-59F3E5DF3CF1}"/>
              </a:ext>
            </a:extLst>
          </p:cNvPr>
          <p:cNvSpPr/>
          <p:nvPr/>
        </p:nvSpPr>
        <p:spPr>
          <a:xfrm>
            <a:off x="-8763" y="35496"/>
            <a:ext cx="1220076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1: Gating strategies to evaluate CD34+CD38-CD123+ leukemic stem cells in AML patien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s were done on fresh cells. A total of 5.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ary AML blast cells were stained with the following conjugated antibodies: CD38-APC and CD123-Percp-Cy5.5 (BD Biosciences, Franklin Lakes, NJ, USA), CD45-KO, CD117-AA750 and CD34-PC7 (Beckman–Coulter Inc., Brea, CA, USA). Analyses were performed on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vio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cytometer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luz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(Beckman-Coulter Inc., Brea, CA, USA) in an institutional hematology laboratory in Toulouse (France).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Blast cells were selected as CD45 low SSC low leukocytes according to FAB classification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0698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152</Words>
  <Application>Microsoft Office PowerPoint</Application>
  <PresentationFormat>Grand écran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çois Vergez</dc:creator>
  <cp:lastModifiedBy>François Vergez</cp:lastModifiedBy>
  <cp:revision>10</cp:revision>
  <dcterms:created xsi:type="dcterms:W3CDTF">2019-09-26T06:08:02Z</dcterms:created>
  <dcterms:modified xsi:type="dcterms:W3CDTF">2020-04-05T16:05:13Z</dcterms:modified>
</cp:coreProperties>
</file>